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CLEAN Alison" initials="MA" lastIdx="2" clrIdx="0">
    <p:extLst>
      <p:ext uri="{19B8F6BF-5375-455C-9EA6-DF929625EA0E}">
        <p15:presenceInfo xmlns:p15="http://schemas.microsoft.com/office/powerpoint/2012/main" userId="MCLEAN Aliso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57"/>
    <p:restoredTop sz="91642"/>
  </p:normalViewPr>
  <p:slideViewPr>
    <p:cSldViewPr snapToGrid="0" snapToObjects="1">
      <p:cViewPr varScale="1">
        <p:scale>
          <a:sx n="106" d="100"/>
          <a:sy n="106" d="100"/>
        </p:scale>
        <p:origin x="5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FF5D95-3316-854B-B51D-53E1631017AB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675B83-6853-6E4A-91A3-0EC63C2046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06320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675B83-6853-6E4A-91A3-0EC63C2046D0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88716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CFD8681-DF07-DC4F-BEF6-FEE9A56F7E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DD38D67-1607-6240-8017-5ED03328EB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285A597-3152-264D-AAB7-E4097DDAA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8AB86B0-F34B-BD42-BCB7-BC64622E1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4F1C20-4896-1A47-8E85-AFA09B190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0636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441A1A3-CE93-104A-9A94-4206071166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AB42497-9ECA-5446-AD27-0B295FE6FA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CB27DE2-C51A-B341-B62C-26658D836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6F26CB6-6686-A94E-8409-76D26BCF3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305B8CB-5609-E44F-9CC9-BCA559BDB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0582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0615B3E-C2EA-724E-95E6-CC61E79FAF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42CF774-B367-D94C-95D8-739E205A02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516FCF5-D823-144D-9A08-0F5A44E92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34B0AE7-064E-F641-8285-FD62F703C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327BE05-5F88-824D-A79B-25F93083B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2003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E3C349F-3A3A-C74A-8CFC-018556407B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16B6CB4-DADA-D044-BEE6-D4CD99269F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2B2D985-0309-7548-9202-BBA2DDB6A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16571CC-6275-E140-B2A0-B586C5429F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8D17A3D-0F08-E242-9842-6A7DDDB04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468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79832C-6325-A041-A8BF-92AD912AB7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84407D1-7020-B147-ADBD-A23EABA410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6EBA3D-753C-934C-9901-922B68C92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D41E9A-7B26-C443-A805-E50F9782E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A3CB63E-6438-B44C-8D52-EEB62A10D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1876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9D662F-9547-4146-9F1D-DDCDCB03DD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FF1C362-22D9-EC4E-BAEF-738E859BAD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6ED7812-1BCE-134E-8324-3FEC8423DA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F0239B9-2D58-3D4B-86C7-814A34BDB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95CDEF5-99BC-5042-A68D-9DAD7517A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B6876F0-1C92-C841-821B-4BE408899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1189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35082A0-F9CE-8846-912D-B6DC8E375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6EAC895-FDE8-C448-8945-C516EBFF20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E6F7618-D870-8747-914D-BDD5AFBD69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07610092-76E8-D841-8F76-72E67F9E25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6977F0F-6269-134A-A135-9AF8C98467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1337AD4-6902-2C41-BC61-16EC39622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FA72FFF-759E-1D48-9A13-A9FEAA9C1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7AD9DC3-13AF-E34A-AAD1-93B3D5F67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7006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8893D2-1CC0-294C-95D1-1DA109C000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2735868-BAC5-CB46-9C94-933680422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DC4A1E7-F0A4-AA4C-AB07-6A60C7969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177371E-F7F5-4D43-AA02-47FB8B756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2498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5D29E90-F993-C945-BAAB-D4A747333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38F4975-7C3C-0B43-AD2E-8B7263679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156BDF6-1DD1-A14E-A325-0D67B1FDA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9387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40D20F0-3959-CD45-A41B-EFCB5243F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486159D-96D4-BF43-A884-B835F4BAFB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34AC1ED-0AB1-C84B-9947-3C44E6DABB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CB11D7B-0971-934C-8BB3-44F626A9F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20E6FF8-580C-3449-8EDB-2E3C95153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0043C6B-A7D8-D64E-B2DB-40BDFA4DC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8036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F5A047-076F-F14D-91C3-70E77D42B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09EFA17D-0B55-0C4E-9D27-163DA4D823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9F8DCD6-FC42-9645-BDCD-3688AC2164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D72BD8C-94D6-3C46-9D5B-7BDA9210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C7D7643-4A91-BA4C-9082-09B77E97A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70DD8A8-D023-F041-A5E3-DDD23C4B3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4887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A019865-4A75-824C-BAD2-B46ED62EE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2283C6C-9916-9B48-B38B-3297606EA4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F5AC0B-884E-B743-AA2F-494EC0514F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FCEF3-E77C-9E45-9A08-09AFCC04D807}" type="datetimeFigureOut">
              <a:rPr lang="fr-FR" smtClean="0"/>
              <a:t>15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52BDD73-74C2-8348-BB99-894E4A2DD0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F63A91D-B62A-4B4B-B87D-BEBBC872C3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5225E4-0E41-4C47-BBC1-20A4ABA22F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5110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>
            <a:extLst>
              <a:ext uri="{FF2B5EF4-FFF2-40B4-BE49-F238E27FC236}">
                <a16:creationId xmlns:a16="http://schemas.microsoft.com/office/drawing/2014/main" id="{B99F6E62-4DF4-B946-81D6-970E07525A9A}"/>
              </a:ext>
            </a:extLst>
          </p:cNvPr>
          <p:cNvSpPr txBox="1"/>
          <p:nvPr/>
        </p:nvSpPr>
        <p:spPr>
          <a:xfrm>
            <a:off x="1249311" y="140094"/>
            <a:ext cx="10131133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fr-FR" sz="14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ensity plot of propensity score of included patients according to SDD.</a:t>
            </a:r>
          </a:p>
          <a:p>
            <a:r>
              <a:rPr lang="fr-FR" sz="1400" b="0" i="0" dirty="0" err="1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ensity</a:t>
            </a:r>
            <a:r>
              <a:rPr lang="fr-FR" sz="1400" b="0" i="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lots show the distribution of </a:t>
            </a:r>
            <a:r>
              <a:rPr lang="fr-FR" sz="1400" b="0" i="0" dirty="0" err="1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pensity</a:t>
            </a:r>
            <a:r>
              <a:rPr lang="fr-FR" sz="1400" b="0" i="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cores in the SDD and Standard Care groups </a:t>
            </a:r>
            <a:r>
              <a:rPr lang="fr-FR" sz="1400" b="0" i="0" dirty="0" err="1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fr-FR" sz="1400" b="0" i="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fr-FR" sz="1400" b="0" i="0" dirty="0" err="1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1400" b="0" i="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fr-FR" sz="1400" b="0" i="0" dirty="0" err="1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tching</a:t>
            </a:r>
            <a:r>
              <a:rPr lang="fr-FR" sz="1400" b="0" i="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400" b="0" i="0" u="none" strike="noStrike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fr-FR" sz="14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EDC1767-C0BE-0844-9B05-33929E087904}"/>
              </a:ext>
            </a:extLst>
          </p:cNvPr>
          <p:cNvSpPr/>
          <p:nvPr/>
        </p:nvSpPr>
        <p:spPr>
          <a:xfrm>
            <a:off x="7904749" y="3485168"/>
            <a:ext cx="2795173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D50E3E0-76CF-A043-8490-F93AD5F023FD}"/>
              </a:ext>
            </a:extLst>
          </p:cNvPr>
          <p:cNvSpPr/>
          <p:nvPr/>
        </p:nvSpPr>
        <p:spPr>
          <a:xfrm>
            <a:off x="8100435" y="2940315"/>
            <a:ext cx="2905432" cy="44245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9CBDF28-DE56-6245-8335-717F1A7D5DA4}"/>
              </a:ext>
            </a:extLst>
          </p:cNvPr>
          <p:cNvSpPr/>
          <p:nvPr/>
        </p:nvSpPr>
        <p:spPr>
          <a:xfrm>
            <a:off x="8606599" y="3255629"/>
            <a:ext cx="2905432" cy="44245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500DFA6-0B99-B34C-B60A-AF7E43249D54}"/>
              </a:ext>
            </a:extLst>
          </p:cNvPr>
          <p:cNvSpPr/>
          <p:nvPr/>
        </p:nvSpPr>
        <p:spPr>
          <a:xfrm>
            <a:off x="8475012" y="3189041"/>
            <a:ext cx="2905432" cy="44245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362A2A8-F85A-CC40-B092-F0CBC221B550}"/>
              </a:ext>
            </a:extLst>
          </p:cNvPr>
          <p:cNvSpPr/>
          <p:nvPr/>
        </p:nvSpPr>
        <p:spPr>
          <a:xfrm>
            <a:off x="8355474" y="3189040"/>
            <a:ext cx="2905432" cy="44245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D6E24228-13AE-5840-AB27-47FEC687E15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001"/>
          <a:stretch/>
        </p:blipFill>
        <p:spPr>
          <a:xfrm>
            <a:off x="3089310" y="1271152"/>
            <a:ext cx="5022117" cy="4871397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A968C35A-0C71-7740-A982-116C3E69678A}"/>
              </a:ext>
            </a:extLst>
          </p:cNvPr>
          <p:cNvSpPr/>
          <p:nvPr/>
        </p:nvSpPr>
        <p:spPr>
          <a:xfrm>
            <a:off x="7343765" y="3104762"/>
            <a:ext cx="2905432" cy="44245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476995BD-84A9-AD43-8490-7255B1BE3876}"/>
              </a:ext>
            </a:extLst>
          </p:cNvPr>
          <p:cNvSpPr txBox="1"/>
          <p:nvPr/>
        </p:nvSpPr>
        <p:spPr>
          <a:xfrm>
            <a:off x="7385920" y="3258132"/>
            <a:ext cx="2538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ive Digestive Decontamination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72725F22-ECBC-184C-9D97-A6EEF2446436}"/>
              </a:ext>
            </a:extLst>
          </p:cNvPr>
          <p:cNvSpPr txBox="1"/>
          <p:nvPr/>
        </p:nvSpPr>
        <p:spPr>
          <a:xfrm>
            <a:off x="3380873" y="87875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1C535CE-79C1-7541-9D3A-DBD3F3872A3B}"/>
              </a:ext>
            </a:extLst>
          </p:cNvPr>
          <p:cNvSpPr txBox="1"/>
          <p:nvPr/>
        </p:nvSpPr>
        <p:spPr>
          <a:xfrm>
            <a:off x="5512435" y="87875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14812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F12EE8FC-3CC1-9349-BFBA-41961E29168A}"/>
              </a:ext>
            </a:extLst>
          </p:cNvPr>
          <p:cNvSpPr txBox="1"/>
          <p:nvPr/>
        </p:nvSpPr>
        <p:spPr>
          <a:xfrm>
            <a:off x="1390248" y="1301016"/>
            <a:ext cx="2897521" cy="44550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ance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xe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ll</a:t>
            </a:r>
          </a:p>
          <a:p>
            <a:pPr algn="r"/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mmer</a:t>
            </a:r>
            <a:endParaRPr lang="fr-FR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</a:t>
            </a:r>
          </a:p>
          <a:p>
            <a:pPr algn="r"/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ring</a:t>
            </a:r>
            <a:endParaRPr lang="fr-FR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tropenia</a:t>
            </a:r>
            <a:endParaRPr lang="fr-FR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ther</a:t>
            </a:r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pression</a:t>
            </a:r>
            <a:endParaRPr lang="fr-FR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pression</a:t>
            </a:r>
            <a:endParaRPr lang="fr-FR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Venous Catheter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PSII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 of admission 2017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 of admission 2018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 of admission 2019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 of admission 2020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 of admission 2021</a:t>
            </a:r>
          </a:p>
          <a:p>
            <a:pPr algn="r"/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ar</a:t>
            </a:r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admission 2022</a:t>
            </a:r>
          </a:p>
          <a:p>
            <a:pPr algn="r"/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cal-Surgical</a:t>
            </a:r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CU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mission from home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uma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iotherapy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mission for elected surgery</a:t>
            </a: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mission for emergency </a:t>
            </a:r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gery</a:t>
            </a:r>
            <a:endParaRPr lang="fr-FR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mission for </a:t>
            </a:r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cal</a:t>
            </a:r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son</a:t>
            </a:r>
            <a:endParaRPr lang="fr-FR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fr-F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VID-19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DD65855-4132-F445-B941-E43E43F65AA0}"/>
              </a:ext>
            </a:extLst>
          </p:cNvPr>
          <p:cNvSpPr txBox="1"/>
          <p:nvPr/>
        </p:nvSpPr>
        <p:spPr>
          <a:xfrm>
            <a:off x="453512" y="272385"/>
            <a:ext cx="1144670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ry Figure 2. </a:t>
            </a:r>
            <a:r>
              <a:rPr lang="fr-FR" sz="14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tandardized mean differences of baseline characteristics in unmatched and 1:1 propensity adjusted cohorts.</a:t>
            </a:r>
            <a:endParaRPr lang="fr-FR" sz="1400" dirty="0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E5A17CBE-F28A-8F4F-AC8E-E19162A67D7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783"/>
          <a:stretch/>
        </p:blipFill>
        <p:spPr>
          <a:xfrm>
            <a:off x="4205234" y="1140488"/>
            <a:ext cx="3932711" cy="46775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94665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36</TotalTime>
  <Words>126</Words>
  <Application>Microsoft Macintosh PowerPoint</Application>
  <PresentationFormat>Grand écran</PresentationFormat>
  <Paragraphs>33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th Bess</dc:creator>
  <cp:lastModifiedBy>Math Bess</cp:lastModifiedBy>
  <cp:revision>31</cp:revision>
  <dcterms:created xsi:type="dcterms:W3CDTF">2023-09-05T11:38:51Z</dcterms:created>
  <dcterms:modified xsi:type="dcterms:W3CDTF">2023-11-18T13:32:50Z</dcterms:modified>
</cp:coreProperties>
</file>